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4" y="4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74625145312709"/>
          <c:y val="2.5214249025865713E-2"/>
          <c:w val="0.61332867466066809"/>
          <c:h val="0.89580882080392266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ample collection to result given to mothe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Period 6</c:v>
                </c:pt>
                <c:pt idx="1">
                  <c:v>Period 5</c:v>
                </c:pt>
                <c:pt idx="2">
                  <c:v>Period 4</c:v>
                </c:pt>
                <c:pt idx="3">
                  <c:v>Period 3</c:v>
                </c:pt>
                <c:pt idx="4">
                  <c:v>Period 2</c:v>
                </c:pt>
                <c:pt idx="5">
                  <c:v>Period 1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50</c:v>
                </c:pt>
                <c:pt idx="1">
                  <c:v>64</c:v>
                </c:pt>
                <c:pt idx="2">
                  <c:v>51</c:v>
                </c:pt>
                <c:pt idx="3">
                  <c:v>72</c:v>
                </c:pt>
                <c:pt idx="4">
                  <c:v>158</c:v>
                </c:pt>
                <c:pt idx="5">
                  <c:v>49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ample collection to result at clini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Period 6</c:v>
                </c:pt>
                <c:pt idx="1">
                  <c:v>Period 5</c:v>
                </c:pt>
                <c:pt idx="2">
                  <c:v>Period 4</c:v>
                </c:pt>
                <c:pt idx="3">
                  <c:v>Period 3</c:v>
                </c:pt>
                <c:pt idx="4">
                  <c:v>Period 2</c:v>
                </c:pt>
                <c:pt idx="5">
                  <c:v>Period 1</c:v>
                </c:pt>
              </c:strCache>
            </c:strRef>
          </c:cat>
          <c:val>
            <c:numRef>
              <c:f>Sheet1!$C$2:$C$7</c:f>
              <c:numCache>
                <c:formatCode>General</c:formatCode>
                <c:ptCount val="6"/>
                <c:pt idx="0">
                  <c:v>37</c:v>
                </c:pt>
                <c:pt idx="1">
                  <c:v>44</c:v>
                </c:pt>
                <c:pt idx="2">
                  <c:v>28</c:v>
                </c:pt>
                <c:pt idx="3">
                  <c:v>46</c:v>
                </c:pt>
                <c:pt idx="4">
                  <c:v>143</c:v>
                </c:pt>
                <c:pt idx="5">
                  <c:v>37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493519992"/>
        <c:axId val="495650912"/>
      </c:barChart>
      <c:catAx>
        <c:axId val="493519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5650912"/>
        <c:crosses val="autoZero"/>
        <c:auto val="1"/>
        <c:lblAlgn val="ctr"/>
        <c:lblOffset val="100"/>
        <c:noMultiLvlLbl val="0"/>
      </c:catAx>
      <c:valAx>
        <c:axId val="495650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dirty="0" smtClean="0">
                    <a:solidFill>
                      <a:schemeClr val="tx1"/>
                    </a:solidFill>
                  </a:rPr>
                  <a:t>Days</a:t>
                </a:r>
                <a:endParaRPr lang="en-US" sz="14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3519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8562193616258795"/>
          <c:y val="1.0150815882379221E-2"/>
          <c:w val="0.41367119467835556"/>
          <c:h val="0.10599867013933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778F1-FFED-4DFB-B6B2-08E8FAA881F7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E7C6F-1E25-4137-B868-A760EAB1E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159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EE7C6F-1E25-4137-B868-A760EAB1E2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4163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861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44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55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187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938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23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633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35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768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517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6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5D9A2-B731-4831-B310-3D744F26E69F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933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1479964955"/>
              </p:ext>
            </p:extLst>
          </p:nvPr>
        </p:nvGraphicFramePr>
        <p:xfrm>
          <a:off x="118736" y="177123"/>
          <a:ext cx="8923858" cy="66097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810700" y="537004"/>
            <a:ext cx="2321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, 130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70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36987" y="793764"/>
            <a:ext cx="2355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ange: 11, 409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70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201600" y="1785580"/>
            <a:ext cx="2208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3, 267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42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777973" y="1514061"/>
            <a:ext cx="2253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1, 257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42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62530" y="3754041"/>
            <a:ext cx="26543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3, 140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29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29853" y="2520692"/>
            <a:ext cx="29351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, 403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226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733045" y="2784651"/>
            <a:ext cx="3127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2, 416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226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51607" y="3481981"/>
            <a:ext cx="3265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3, 84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29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992068" y="4481055"/>
            <a:ext cx="34216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, 148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31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543780" y="4754846"/>
            <a:ext cx="26970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2, 149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31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783201" y="5476086"/>
            <a:ext cx="2791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, 82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65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114896" y="5738741"/>
            <a:ext cx="2401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Range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2, 126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=65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0436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66</TotalTime>
  <Words>122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cliffe, Catherine G.</dc:creator>
  <cp:lastModifiedBy>Sutcliffe, Catherine G.</cp:lastModifiedBy>
  <cp:revision>108</cp:revision>
  <dcterms:created xsi:type="dcterms:W3CDTF">2018-08-17T18:53:56Z</dcterms:created>
  <dcterms:modified xsi:type="dcterms:W3CDTF">2020-02-10T21:16:09Z</dcterms:modified>
</cp:coreProperties>
</file>